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1211"/>
  </p:normalViewPr>
  <p:slideViewPr>
    <p:cSldViewPr snapToGrid="0" snapToObjects="1">
      <p:cViewPr varScale="1">
        <p:scale>
          <a:sx n="102" d="100"/>
          <a:sy n="102" d="100"/>
        </p:scale>
        <p:origin x="182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FA5237-5D35-F049-89A6-C14F3015AB55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B1F95D-21CE-F447-9B97-DC210F0A78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12365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ditional file 1: Fig. 1 </a:t>
            </a:r>
            <a:r>
              <a:rPr kumimoji="1" lang="en-IN" altLang="ja-JP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-banding analysis of the study patient</a:t>
            </a:r>
            <a:endParaRPr kumimoji="1" lang="ja-JP" altLang="ja-JP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B1F95D-21CE-F447-9B97-DC210F0A78E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15261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34B86-D17B-9746-B8C4-BF2025B7DEFB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D8291-75DB-6641-B8B9-D54C42B27B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9485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34B86-D17B-9746-B8C4-BF2025B7DEFB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D8291-75DB-6641-B8B9-D54C42B27B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1731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34B86-D17B-9746-B8C4-BF2025B7DEFB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D8291-75DB-6641-B8B9-D54C42B27B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06621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34B86-D17B-9746-B8C4-BF2025B7DEFB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D8291-75DB-6641-B8B9-D54C42B27B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1478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34B86-D17B-9746-B8C4-BF2025B7DEFB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D8291-75DB-6641-B8B9-D54C42B27B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6596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34B86-D17B-9746-B8C4-BF2025B7DEFB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D8291-75DB-6641-B8B9-D54C42B27B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42224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34B86-D17B-9746-B8C4-BF2025B7DEFB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D8291-75DB-6641-B8B9-D54C42B27B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9374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34B86-D17B-9746-B8C4-BF2025B7DEFB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D8291-75DB-6641-B8B9-D54C42B27B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86009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34B86-D17B-9746-B8C4-BF2025B7DEFB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D8291-75DB-6641-B8B9-D54C42B27B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90099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34B86-D17B-9746-B8C4-BF2025B7DEFB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D8291-75DB-6641-B8B9-D54C42B27B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35726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34B86-D17B-9746-B8C4-BF2025B7DEFB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D8291-75DB-6641-B8B9-D54C42B27B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8052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334B86-D17B-9746-B8C4-BF2025B7DEFB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AD8291-75DB-6641-B8B9-D54C42B27B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478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F4920092-A404-BC47-8B39-493C0DD6EC1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72000" y="1257300"/>
            <a:ext cx="4331019" cy="345440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BF58FA12-0FEC-7C4A-8871-A77CC618AB2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9856" y="1257300"/>
            <a:ext cx="4214663" cy="345440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C30CEDC3-58B3-CD4A-B95B-D2D6B4F84CC9}"/>
              </a:ext>
            </a:extLst>
          </p:cNvPr>
          <p:cNvSpPr/>
          <p:nvPr/>
        </p:nvSpPr>
        <p:spPr>
          <a:xfrm>
            <a:off x="693855" y="857190"/>
            <a:ext cx="327660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 defTabSz="914400">
              <a:defRPr/>
            </a:pPr>
            <a:r>
              <a:rPr kumimoji="1" lang="en-IN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45,X,dic(Y;22)(p11.3;p11.2)</a:t>
            </a: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BB518C18-4705-AE43-B5C3-538D00980541}"/>
              </a:ext>
            </a:extLst>
          </p:cNvPr>
          <p:cNvSpPr/>
          <p:nvPr/>
        </p:nvSpPr>
        <p:spPr>
          <a:xfrm>
            <a:off x="6362951" y="857190"/>
            <a:ext cx="71205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 defTabSz="914400">
              <a:defRPr/>
            </a:pPr>
            <a:r>
              <a:rPr kumimoji="1" lang="en-IN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45,X</a:t>
            </a: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C6CF8526-93B4-584F-AB9F-E8059218B163}"/>
              </a:ext>
            </a:extLst>
          </p:cNvPr>
          <p:cNvSpPr/>
          <p:nvPr/>
        </p:nvSpPr>
        <p:spPr>
          <a:xfrm>
            <a:off x="119895" y="111254"/>
            <a:ext cx="8622873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defTabSz="914400">
              <a:defRPr/>
            </a:pPr>
            <a:r>
              <a:rPr kumimoji="1" lang="en-IN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Additional file1: Fig. 1 G-banding analysis of the study patient </a:t>
            </a:r>
          </a:p>
        </p:txBody>
      </p: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054F9D3F-934C-1849-9B47-8E2142FD59A9}"/>
              </a:ext>
            </a:extLst>
          </p:cNvPr>
          <p:cNvGrpSpPr/>
          <p:nvPr/>
        </p:nvGrpSpPr>
        <p:grpSpPr>
          <a:xfrm>
            <a:off x="179855" y="4938755"/>
            <a:ext cx="3548293" cy="1722634"/>
            <a:chOff x="179855" y="4938755"/>
            <a:chExt cx="3548293" cy="1722634"/>
          </a:xfrm>
        </p:grpSpPr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73612957-DED9-5B43-9B4E-6AF330AB60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21827" b="8014"/>
            <a:stretch/>
          </p:blipFill>
          <p:spPr>
            <a:xfrm rot="10800000">
              <a:off x="2005589" y="4938755"/>
              <a:ext cx="1538834" cy="1353302"/>
            </a:xfrm>
            <a:prstGeom prst="rect">
              <a:avLst/>
            </a:prstGeom>
          </p:spPr>
        </p:pic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1A33FD31-09C5-A94C-8C44-E5BEBC6B7623}"/>
                </a:ext>
              </a:extLst>
            </p:cNvPr>
            <p:cNvSpPr txBox="1"/>
            <p:nvPr/>
          </p:nvSpPr>
          <p:spPr>
            <a:xfrm>
              <a:off x="179856" y="5098738"/>
              <a:ext cx="193375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Chromosome Y</a:t>
              </a:r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349B6011-51B4-A840-8C54-A90646D824B1}"/>
                </a:ext>
              </a:extLst>
            </p:cNvPr>
            <p:cNvSpPr txBox="1"/>
            <p:nvPr/>
          </p:nvSpPr>
          <p:spPr>
            <a:xfrm>
              <a:off x="179855" y="5705391"/>
              <a:ext cx="193375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Chromosome 22</a:t>
              </a:r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0E9FE17D-9584-AB43-9202-6EFA6EED9759}"/>
                </a:ext>
              </a:extLst>
            </p:cNvPr>
            <p:cNvSpPr/>
            <p:nvPr/>
          </p:nvSpPr>
          <p:spPr>
            <a:xfrm>
              <a:off x="2491912" y="6292057"/>
              <a:ext cx="123623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kern="0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  <a:cs typeface="Arial" panose="020B0604020202020204" pitchFamily="34" charset="0"/>
                </a:rPr>
                <a:t> dic(Y;22)</a:t>
              </a:r>
              <a:r>
                <a:rPr lang="ja-JP" altLang="ja-JP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177903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</TotalTime>
  <Words>54</Words>
  <Application>Microsoft Macintosh PowerPoint</Application>
  <PresentationFormat>画面に合わせる (4:3)</PresentationFormat>
  <Paragraphs>8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河村 理恵</dc:creator>
  <cp:lastModifiedBy>河村 理恵</cp:lastModifiedBy>
  <cp:revision>10</cp:revision>
  <cp:lastPrinted>2021-05-18T07:34:52Z</cp:lastPrinted>
  <dcterms:created xsi:type="dcterms:W3CDTF">2020-09-14T05:43:55Z</dcterms:created>
  <dcterms:modified xsi:type="dcterms:W3CDTF">2021-06-24T14:04:33Z</dcterms:modified>
</cp:coreProperties>
</file>